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95"/>
    <p:restoredTop sz="94591"/>
  </p:normalViewPr>
  <p:slideViewPr>
    <p:cSldViewPr snapToGrid="0">
      <p:cViewPr varScale="1">
        <p:scale>
          <a:sx n="105" d="100"/>
          <a:sy n="105" d="100"/>
        </p:scale>
        <p:origin x="224" y="4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7804C-1CCC-19D1-4AD0-336C65F01C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C518E0-333C-3195-FACE-F1470DA9C4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E40B2E-90A5-CA13-F2B7-D6D9BA67E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B50948-1A18-B8DB-3FEA-EB008BEE9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8CB327-2630-54B4-8E0D-3E5C1C150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8150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344926-D899-B412-E895-F31392EDC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E2CF11-BE93-FC2F-9857-5F7658CCBB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EABB5-FDB0-322A-E081-692F96633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CC3DE-50D7-A1EB-EF17-4CB1231B2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5B88CB-AAF9-664B-1EBF-00F46A4F0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248132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F6BEE4-4D0A-AAD9-E2F4-A1F31B4978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408C7F-1052-8ACE-1B4E-6335DE9C9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9AA949-B756-565F-36F3-724470521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7D1549-9668-5B9A-34C3-EF9D3ACB1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60D474-B695-2E8A-2B68-2486EF1EAB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49301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70BEE-A34C-B74B-9871-3F1C221BA6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07F63A-1B26-8C96-14E0-5201C781DE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032E9-1789-2519-F152-3B910B0AC3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E4066-4A4B-928B-254F-2692616A0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ACB9F8-A359-B3D8-43BD-67BF620C9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378448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493C44-B01B-3FBA-BDE2-7D361D665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07FBC3-190D-EA5E-2207-3AAF686EA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A3EA5-8186-D637-C36A-10B865153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C57571-8962-4B3F-A896-A4E50410A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BBBA1E-37E8-776A-2DAD-56A09D35A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5222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BC3D0C-F16B-E260-ED21-B2DB77B44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AEE860-07AC-4F5A-84EE-457FECEF9E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05F101-8283-8A67-2C93-1FF93F86C2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BEF442-4D4B-D11F-58FA-6175135DC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6FF664-C82E-E657-BB24-2CD531A975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86B730-4377-EDEF-8D4A-EC2635B75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73330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6E340-EA79-5ED2-39A9-A2792600E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18BDCC-DC30-8CAD-5440-E8261642D7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1BB737-235B-7BE6-E251-D57C8CC329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7C837F-5FAC-E655-09B5-F1D797C603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0FFE88-A534-25DF-A3E0-B9F54E8A52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4123FB-7DDB-630C-B26C-87D1C9B9A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B1EE98-3E46-A7FD-5E02-51746E738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EFE94F-F41E-8BE1-431A-FB23FE246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92639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F5E00-A941-BF6B-5895-3F566603F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548293-E379-E8CE-51DC-BAA6941C16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E4A763-E5DB-3F01-83EA-FFA6A7B8C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5FAB93-A589-9263-ADCC-287E932EA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965472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EDDAFD-B7E3-5DFE-0289-DF27A4113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5923F42-D7AD-4426-19B6-9FFE524482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85427D-E9B8-644F-7839-8E15E750A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190762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EE701-5B3F-D2CF-D467-8FF71430E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3090F3-EDD2-3517-84CA-60C827893A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F4D0F1-E19B-0A2E-EBAE-3924047390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B56A2E-E2B9-6EC7-B38A-CB3C23A05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E7EA03-C7BC-5C08-B2BE-F284EF0DB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F08347-2F75-D8EF-7044-6BDA36477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735197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31265-D80B-64B3-260D-BDD38C449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C69D04-8104-70AC-5273-AA0EB51766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665B4E-C257-0D33-090C-3344D79123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254ABF-1A3E-1065-4784-B91FA01B1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84E36B-B66C-A8C6-293C-EA5CA6655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C47CA4-9A4A-279D-05D5-613A366A3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631968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3DBFB2-50A5-1995-6E5A-4A923773EF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2C48F6-3DD2-6799-7514-B04BC3874F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3F0AC9-B5C4-1666-1CB9-BD83D0AE58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1C6A92-C0BB-B84E-AD7F-6D1AE7E4A1FD}" type="datetimeFigureOut">
              <a:rPr lang="en-TH" smtClean="0"/>
              <a:t>6/3/2025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246AF0-54AF-B435-6298-69EE105865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A57284-5E36-22E7-D2BE-913E1E4C3B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E898E3-444B-4345-9305-7B669171D909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4286187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a person's reaction&#10;&#10;AI-generated content may be incorrect.">
            <a:extLst>
              <a:ext uri="{FF2B5EF4-FFF2-40B4-BE49-F238E27FC236}">
                <a16:creationId xmlns:a16="http://schemas.microsoft.com/office/drawing/2014/main" id="{CFD799A2-8226-E8EC-074B-ADF316EE7E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999384"/>
            <a:ext cx="5826208" cy="2962759"/>
          </a:xfrm>
          <a:prstGeom prst="rect">
            <a:avLst/>
          </a:prstGeom>
        </p:spPr>
      </p:pic>
      <p:pic>
        <p:nvPicPr>
          <p:cNvPr id="7" name="Picture 6" descr="A graph of a person's body&#10;&#10;AI-generated content may be incorrect.">
            <a:extLst>
              <a:ext uri="{FF2B5EF4-FFF2-40B4-BE49-F238E27FC236}">
                <a16:creationId xmlns:a16="http://schemas.microsoft.com/office/drawing/2014/main" id="{74B61E29-3D6E-2626-DDD8-0D24FA8A9F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9018" y="2061931"/>
            <a:ext cx="5822104" cy="28376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3C6ACAE-308A-4BBD-6E45-728E4070C605}"/>
              </a:ext>
            </a:extLst>
          </p:cNvPr>
          <p:cNvSpPr txBox="1"/>
          <p:nvPr/>
        </p:nvSpPr>
        <p:spPr>
          <a:xfrm>
            <a:off x="481669" y="1255776"/>
            <a:ext cx="4862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PLC analysis of the </a:t>
            </a:r>
            <a:r>
              <a:rPr lang="en-US" dirty="0" err="1"/>
              <a:t>piperine</a:t>
            </a:r>
            <a:r>
              <a:rPr lang="en-US" dirty="0"/>
              <a:t> used in this study</a:t>
            </a:r>
            <a:endParaRPr lang="en-TH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830497-E71C-67BA-9615-C20C65D9095C}"/>
              </a:ext>
            </a:extLst>
          </p:cNvPr>
          <p:cNvSpPr txBox="1"/>
          <p:nvPr/>
        </p:nvSpPr>
        <p:spPr>
          <a:xfrm>
            <a:off x="6054230" y="1255776"/>
            <a:ext cx="6137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PLC analysis of the </a:t>
            </a:r>
            <a:r>
              <a:rPr lang="en-US" dirty="0" err="1"/>
              <a:t>piperine</a:t>
            </a:r>
            <a:r>
              <a:rPr lang="th-TH" dirty="0"/>
              <a:t> </a:t>
            </a:r>
            <a:r>
              <a:rPr lang="en-US" dirty="0"/>
              <a:t>standard (Sigma-Aldrich, USA)</a:t>
            </a:r>
            <a:endParaRPr lang="en-TH" dirty="0"/>
          </a:p>
        </p:txBody>
      </p:sp>
    </p:spTree>
    <p:extLst>
      <p:ext uri="{BB962C8B-B14F-4D97-AF65-F5344CB8AC3E}">
        <p14:creationId xmlns:p14="http://schemas.microsoft.com/office/powerpoint/2010/main" val="3994591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0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thi Asavapanumas</dc:creator>
  <cp:lastModifiedBy>Nithi Asavapanumas</cp:lastModifiedBy>
  <cp:revision>1</cp:revision>
  <dcterms:created xsi:type="dcterms:W3CDTF">2025-03-06T06:21:27Z</dcterms:created>
  <dcterms:modified xsi:type="dcterms:W3CDTF">2025-03-06T06:29:41Z</dcterms:modified>
</cp:coreProperties>
</file>